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6" r:id="rId2"/>
    <p:sldId id="258" r:id="rId3"/>
    <p:sldId id="288" r:id="rId4"/>
    <p:sldId id="260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서효정" initials="서" lastIdx="1" clrIdx="0">
    <p:extLst>
      <p:ext uri="{19B8F6BF-5375-455C-9EA6-DF929625EA0E}">
        <p15:presenceInfo xmlns:p15="http://schemas.microsoft.com/office/powerpoint/2012/main" userId="27389d18be28d3b9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0"/>
    <p:restoredTop sz="94578"/>
  </p:normalViewPr>
  <p:slideViewPr>
    <p:cSldViewPr snapToGrid="0">
      <p:cViewPr>
        <p:scale>
          <a:sx n="95" d="100"/>
          <a:sy n="95" d="100"/>
        </p:scale>
        <p:origin x="1260" y="-20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0ABC0B-8BF1-40BD-83B0-459D1E879F2D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3BD5A7-5CCF-426A-B109-CBBE9EE0C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2258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EE350-6E4D-43D9-B917-8B341DB49EC9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46154-8714-4FF5-88F5-D11B64AA3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6822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EE350-6E4D-43D9-B917-8B341DB49EC9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46154-8714-4FF5-88F5-D11B64AA3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5949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EE350-6E4D-43D9-B917-8B341DB49EC9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46154-8714-4FF5-88F5-D11B64AA3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489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EE350-6E4D-43D9-B917-8B341DB49EC9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46154-8714-4FF5-88F5-D11B64AA3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961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EE350-6E4D-43D9-B917-8B341DB49EC9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46154-8714-4FF5-88F5-D11B64AA3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7292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EE350-6E4D-43D9-B917-8B341DB49EC9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46154-8714-4FF5-88F5-D11B64AA3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3498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EE350-6E4D-43D9-B917-8B341DB49EC9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46154-8714-4FF5-88F5-D11B64AA3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982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EE350-6E4D-43D9-B917-8B341DB49EC9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46154-8714-4FF5-88F5-D11B64AA3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3039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EE350-6E4D-43D9-B917-8B341DB49EC9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46154-8714-4FF5-88F5-D11B64AA3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58754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EE350-6E4D-43D9-B917-8B341DB49EC9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46154-8714-4FF5-88F5-D11B64AA3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62661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6EE350-6E4D-43D9-B917-8B341DB49EC9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146154-8714-4FF5-88F5-D11B64AA3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3409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6EE350-6E4D-43D9-B917-8B341DB49EC9}" type="datetimeFigureOut">
              <a:rPr lang="en-US" smtClean="0"/>
              <a:t>8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146154-8714-4FF5-88F5-D11B64AA3A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879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987D797-6FDD-B4C5-4B76-DA42E37650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81718"/>
            <a:ext cx="6793666" cy="355715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64A60A5-013C-A118-F83A-0311255C1F70}"/>
              </a:ext>
            </a:extLst>
          </p:cNvPr>
          <p:cNvSpPr txBox="1"/>
          <p:nvPr/>
        </p:nvSpPr>
        <p:spPr>
          <a:xfrm>
            <a:off x="32167" y="5085772"/>
            <a:ext cx="6793666" cy="25853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 algn="just">
              <a:buNone/>
            </a:pP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Histopathological images of 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primary papillary thyroid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arcinoma of case 1. The tumor patterns are composed of complex, branching papillae with fibrovascular cores and 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follicular architecture (HE stain, low magnification a, b, c, d)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uclear features were enlargement, elongation, overlapping with irregular contour, and 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nuclear grooves (HE stain, high magnification e, f). 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just">
              <a:buNone/>
            </a:pPr>
            <a:endParaRPr lang="en-US" dirty="0"/>
          </a:p>
          <a:p>
            <a:pPr marL="0" indent="0" algn="just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436522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28B880-B5B5-EC3F-1682-3745CEA640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E5BE978-6FFE-B293-4F53-48477AB4ED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659" y="649114"/>
            <a:ext cx="6620681" cy="516979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F7B33B9-8556-0828-5BA1-CB326F0F57AD}"/>
              </a:ext>
            </a:extLst>
          </p:cNvPr>
          <p:cNvSpPr txBox="1"/>
          <p:nvPr/>
        </p:nvSpPr>
        <p:spPr>
          <a:xfrm>
            <a:off x="118659" y="6096000"/>
            <a:ext cx="6620681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Supplementary Figure 2</a:t>
            </a:r>
            <a:r>
              <a:rPr lang="en-US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. Histopathological images of the </a:t>
            </a:r>
            <a:r>
              <a:rPr lang="en-US" kern="10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primary </a:t>
            </a:r>
            <a:r>
              <a:rPr lang="en-US" kern="100"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papillary thyroid carcinoma (PTC)</a:t>
            </a:r>
            <a:r>
              <a:rPr lang="en-US" kern="10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 </a:t>
            </a:r>
            <a:r>
              <a:rPr lang="en-US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of </a:t>
            </a:r>
            <a:r>
              <a:rPr lang="en-US" kern="10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case 2 showed multimodule of PTC </a:t>
            </a:r>
            <a:r>
              <a:rPr lang="en-US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on the background of </a:t>
            </a:r>
            <a:r>
              <a:rPr lang="en-US" kern="10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thyroid goiter (</a:t>
            </a:r>
            <a:r>
              <a:rPr lang="en-US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HE stain </a:t>
            </a:r>
            <a:r>
              <a:rPr lang="en-US" kern="10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x 40, a, b), </a:t>
            </a:r>
            <a:r>
              <a:rPr lang="en-US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intercalating </a:t>
            </a:r>
            <a:r>
              <a:rPr lang="en-US" kern="10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fibrous areas, </a:t>
            </a:r>
            <a:r>
              <a:rPr lang="en-US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and calcifying </a:t>
            </a:r>
            <a:r>
              <a:rPr lang="en-US" kern="10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patterns (</a:t>
            </a:r>
            <a:r>
              <a:rPr lang="en-US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HE stain </a:t>
            </a:r>
            <a:r>
              <a:rPr lang="en-US" kern="10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x 40, c), </a:t>
            </a:r>
            <a:r>
              <a:rPr lang="en-US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nuclear features of </a:t>
            </a:r>
            <a:r>
              <a:rPr lang="en-US" kern="10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PTC (</a:t>
            </a:r>
            <a:r>
              <a:rPr lang="en-US" kern="1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HE stain </a:t>
            </a:r>
            <a:r>
              <a:rPr lang="en-US" kern="10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x 200, d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06242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FCD00356-C6CF-7800-AB0E-27CDDF4E6430}"/>
              </a:ext>
            </a:extLst>
          </p:cNvPr>
          <p:cNvSpPr txBox="1"/>
          <p:nvPr/>
        </p:nvSpPr>
        <p:spPr>
          <a:xfrm>
            <a:off x="0" y="5640326"/>
            <a:ext cx="6858000" cy="36933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The histological image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of brain metastases from PTC (HE stain 40, a, invading to brain tissue, asterisk). </a:t>
            </a:r>
            <a:r>
              <a:rPr lang="vi-VN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vi-VN">
                <a:latin typeface="Arial" panose="020B0604020202020204" pitchFamily="34" charset="0"/>
                <a:cs typeface="Arial" panose="020B0604020202020204" pitchFamily="34" charset="0"/>
              </a:rPr>
              <a:t>he </a:t>
            </a:r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majority of </a:t>
            </a:r>
            <a:r>
              <a:rPr lang="vi-VN">
                <a:latin typeface="Arial" panose="020B0604020202020204" pitchFamily="34" charset="0"/>
                <a:cs typeface="Arial" panose="020B0604020202020204" pitchFamily="34" charset="0"/>
              </a:rPr>
              <a:t>papillary structures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vi-VN">
                <a:latin typeface="Arial" panose="020B0604020202020204" pitchFamily="34" charset="0"/>
                <a:cs typeface="Arial" panose="020B0604020202020204" pitchFamily="34" charset="0"/>
              </a:rPr>
              <a:t>cover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ed the </a:t>
            </a:r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tumor </a:t>
            </a:r>
            <a:r>
              <a:rPr lang="vi-VN">
                <a:latin typeface="Arial" panose="020B0604020202020204" pitchFamily="34" charset="0"/>
                <a:cs typeface="Arial" panose="020B0604020202020204" pitchFamily="34" charset="0"/>
              </a:rPr>
              <a:t>peripheral area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 (blue arrow) and</a:t>
            </a:r>
            <a:r>
              <a:rPr lang="vi-VN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in the center there are fibrous stroma and the</a:t>
            </a:r>
            <a:r>
              <a:rPr lang="vi-VN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secreted follicular </a:t>
            </a:r>
            <a:r>
              <a:rPr lang="vi-VN">
                <a:latin typeface="Arial" panose="020B0604020202020204" pitchFamily="34" charset="0"/>
                <a:cs typeface="Arial" panose="020B0604020202020204" pitchFamily="34" charset="0"/>
              </a:rPr>
              <a:t>structures </a:t>
            </a:r>
            <a:r>
              <a:rPr lang="en-US" altLang="ko-KR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vi-VN">
                <a:latin typeface="Arial" panose="020B0604020202020204" pitchFamily="34" charset="0"/>
                <a:cs typeface="Arial" panose="020B0604020202020204" pitchFamily="34" charset="0"/>
              </a:rPr>
              <a:t> contain goiter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 (white arrow)</a:t>
            </a:r>
            <a:r>
              <a:rPr lang="vi-VN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(HE stain x 40, b)</a:t>
            </a:r>
            <a:r>
              <a:rPr lang="vi-VN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No tumor necrosis was seen and mostly rarity of mitosis. Immunohistochemistrical stain presents that tumor </a:t>
            </a:r>
            <a:r>
              <a:rPr lang="vi-VN">
                <a:latin typeface="Arial" panose="020B0604020202020204" pitchFamily="34" charset="0"/>
                <a:cs typeface="Arial" panose="020B0604020202020204" pitchFamily="34" charset="0"/>
              </a:rPr>
              <a:t>cells are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 positive</a:t>
            </a:r>
            <a:r>
              <a:rPr lang="vi-VN">
                <a:latin typeface="Arial" panose="020B0604020202020204" pitchFamily="34" charset="0"/>
                <a:cs typeface="Arial" panose="020B0604020202020204" pitchFamily="34" charset="0"/>
              </a:rPr>
              <a:t> with Thyroglobulin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 (immunohistochemistry stain x 400, d)</a:t>
            </a:r>
            <a:r>
              <a:rPr lang="vi-VN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Nucle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 features of papillary thyroid carcinoma were not clear </a:t>
            </a:r>
            <a:r>
              <a:rPr lang="vi-VN">
                <a:latin typeface="Arial" panose="020B0604020202020204" pitchFamily="34" charset="0"/>
                <a:cs typeface="Arial" panose="020B0604020202020204" pitchFamily="34" charset="0"/>
              </a:rPr>
              <a:t>but poorly </a:t>
            </a:r>
            <a:r>
              <a:rPr lang="vi-VN" dirty="0">
                <a:latin typeface="Arial" panose="020B0604020202020204" pitchFamily="34" charset="0"/>
                <a:cs typeface="Arial" panose="020B0604020202020204" pitchFamily="34" charset="0"/>
              </a:rPr>
              <a:t>thyroid carcinoma and anaplastic thyroid carcinoma were no evidence. </a:t>
            </a:r>
            <a:r>
              <a:rPr lang="en-US" sz="18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The images correlate</a:t>
            </a:r>
            <a:r>
              <a:rPr lang="vi-VN" sz="1800" dirty="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 with high-grade papillary </a:t>
            </a:r>
            <a:r>
              <a:rPr lang="vi-VN" sz="180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thyroid carcinoma</a:t>
            </a:r>
            <a:r>
              <a:rPr lang="en-US" sz="1800">
                <a:effectLst/>
                <a:latin typeface="Arial" panose="020B0604020202020204" pitchFamily="34" charset="0"/>
                <a:ea typeface="Malgun Gothic" panose="020B0503020000020004" pitchFamily="34" charset="-127"/>
                <a:cs typeface="Arial" panose="020B0604020202020204" pitchFamily="34" charset="0"/>
              </a:rPr>
              <a:t>.</a:t>
            </a:r>
            <a:endParaRPr lang="en-V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V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D995BBDA-0420-82C4-2548-5DF9C2259E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08940"/>
            <a:ext cx="6858000" cy="5298829"/>
          </a:xfrm>
          <a:prstGeom prst="rect">
            <a:avLst/>
          </a:prstGeom>
        </p:spPr>
      </p:pic>
      <p:sp>
        <p:nvSpPr>
          <p:cNvPr id="3" name="Arrow: Down 2">
            <a:extLst>
              <a:ext uri="{FF2B5EF4-FFF2-40B4-BE49-F238E27FC236}">
                <a16:creationId xmlns:a16="http://schemas.microsoft.com/office/drawing/2014/main" id="{48F23016-D0E6-EDF7-4015-B098C421FB59}"/>
              </a:ext>
            </a:extLst>
          </p:cNvPr>
          <p:cNvSpPr/>
          <p:nvPr/>
        </p:nvSpPr>
        <p:spPr>
          <a:xfrm>
            <a:off x="6468627" y="1366576"/>
            <a:ext cx="223575" cy="266280"/>
          </a:xfrm>
          <a:prstGeom prst="down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4589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B8FD08-2642-8998-D839-EFC7224FCC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4FDB8A6-2606-2E75-0CC7-6C575DA1CC2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813" y="542540"/>
            <a:ext cx="6790187" cy="270301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13AE4B8-F403-1303-224C-1F73642A3191}"/>
              </a:ext>
            </a:extLst>
          </p:cNvPr>
          <p:cNvSpPr txBox="1"/>
          <p:nvPr/>
        </p:nvSpPr>
        <p:spPr>
          <a:xfrm>
            <a:off x="67813" y="3352130"/>
            <a:ext cx="6722375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Histopathological image of brain metastasis. Papillary 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thyroid carcinoma (PTC)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ncluding papillary structures invaded the 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brain parenchyma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HE stain 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x 100, a, asterisk)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he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apillary structures were covered by tumors presented features of the PTC nucleus, psammoma is in </a:t>
            </a:r>
            <a:r>
              <a:rPr lang="en-US" altLang="ko-KR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center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f the papillary 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score (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E stain </a:t>
            </a:r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x 400, b, black arrow).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23414893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1</TotalTime>
  <Words>335</Words>
  <Application>Microsoft Office PowerPoint</Application>
  <PresentationFormat>Widescreen</PresentationFormat>
  <Paragraphs>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jandra G Delgado</dc:creator>
  <cp:lastModifiedBy>Alejandra G Delgado</cp:lastModifiedBy>
  <cp:revision>9</cp:revision>
  <dcterms:created xsi:type="dcterms:W3CDTF">2022-08-01T10:17:06Z</dcterms:created>
  <dcterms:modified xsi:type="dcterms:W3CDTF">2022-08-09T10:07:40Z</dcterms:modified>
</cp:coreProperties>
</file>